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4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83" t="28478" r="58685" b="34493"/>
          <a:stretch/>
        </p:blipFill>
        <p:spPr bwMode="auto">
          <a:xfrm>
            <a:off x="639731" y="1410610"/>
            <a:ext cx="2230040" cy="1870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1430593" y="3119445"/>
            <a:ext cx="96648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 rot="16200000">
            <a:off x="104292" y="2084554"/>
            <a:ext cx="103263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Intensity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885953" y="1358723"/>
            <a:ext cx="118456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.kud MET3pr</a:t>
            </a:r>
          </a:p>
          <a:p>
            <a:pPr algn="ctr"/>
            <a:r>
              <a:rPr lang="en-US" sz="1000" b="1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cer MET3pr</a:t>
            </a:r>
            <a:endParaRPr lang="en-US" sz="10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 rot="16200000">
            <a:off x="2206561" y="2127917"/>
            <a:ext cx="15424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exp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216655" y="3095049"/>
            <a:ext cx="78192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ECM18</a:t>
            </a:r>
          </a:p>
        </p:txBody>
      </p:sp>
      <p:sp>
        <p:nvSpPr>
          <p:cNvPr id="10" name="Rectangle 9"/>
          <p:cNvSpPr/>
          <p:nvPr/>
        </p:nvSpPr>
        <p:spPr>
          <a:xfrm>
            <a:off x="3789300" y="3095049"/>
            <a:ext cx="78194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YCL067C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330085" y="3095049"/>
            <a:ext cx="779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TDH3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67429" y="1230308"/>
            <a:ext cx="315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760751" y="1230308"/>
            <a:ext cx="315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7429" y="3638261"/>
            <a:ext cx="618384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between the homologous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.cer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kud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tivation dynamics of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.ku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MET3p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lack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.cer MET3p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r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measured by time-lapse fluorescent microscopy. Each trace represents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FP activity in a single cell during induction. The zero time point is the time of methionine removal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eady state level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.ku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.cer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grated at three different locations: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CM1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profile 1),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YCL067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profile 2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DH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profile 3). The data were normalized to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CM1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GFP intensity. Note that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wo promoters show simila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tivation kinetics and stead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ate levels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CR test of primer specificity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lementary to the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ku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 can amplify the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.ku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ET3p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right lane), but not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ce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eft lane).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985846" y="1232558"/>
            <a:ext cx="315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0" t="39865" r="40540" b="18649"/>
          <a:stretch/>
        </p:blipFill>
        <p:spPr>
          <a:xfrm>
            <a:off x="5305245" y="1344752"/>
            <a:ext cx="948044" cy="1774693"/>
          </a:xfrm>
          <a:prstGeom prst="rect">
            <a:avLst/>
          </a:prstGeom>
        </p:spPr>
      </p:pic>
      <p:pic>
        <p:nvPicPr>
          <p:cNvPr id="32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11" t="28478" r="18277" b="34493"/>
          <a:stretch/>
        </p:blipFill>
        <p:spPr bwMode="auto">
          <a:xfrm>
            <a:off x="3091122" y="1410610"/>
            <a:ext cx="2096284" cy="1870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657322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4</TotalTime>
  <Words>167</Words>
  <Application>Microsoft Office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Manyu Du</cp:lastModifiedBy>
  <cp:revision>283</cp:revision>
  <cp:lastPrinted>2016-12-22T22:05:19Z</cp:lastPrinted>
  <dcterms:created xsi:type="dcterms:W3CDTF">2016-06-14T18:48:14Z</dcterms:created>
  <dcterms:modified xsi:type="dcterms:W3CDTF">2017-04-07T20:52:06Z</dcterms:modified>
</cp:coreProperties>
</file>